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804" y="-29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75184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44269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72281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20072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8317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56502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07897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2467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76908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57847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29772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9823FB-ADB1-486E-961A-7392379003CB}" type="datetimeFigureOut">
              <a:rPr lang="en-CA" smtClean="0"/>
              <a:t>16/07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C58492-FECF-4487-B499-C8AE6BCF576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60435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11560" y="757465"/>
            <a:ext cx="8352928" cy="5832648"/>
            <a:chOff x="611560" y="188640"/>
            <a:chExt cx="8352928" cy="5832648"/>
          </a:xfrm>
        </p:grpSpPr>
        <p:sp>
          <p:nvSpPr>
            <p:cNvPr id="4" name="TextBox 3"/>
            <p:cNvSpPr txBox="1"/>
            <p:nvPr/>
          </p:nvSpPr>
          <p:spPr>
            <a:xfrm>
              <a:off x="3779912" y="188640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17505</a:t>
              </a:r>
              <a:endParaRPr lang="en-CA" sz="12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411760" y="980728"/>
              <a:ext cx="648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775</a:t>
              </a:r>
              <a:endParaRPr lang="en-CA" sz="12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932040" y="980728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16730</a:t>
              </a:r>
              <a:endParaRPr lang="en-CA" sz="12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99592" y="1691516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543</a:t>
              </a:r>
              <a:endParaRPr lang="en-CA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555776" y="1691516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39</a:t>
              </a:r>
              <a:endParaRPr lang="en-CA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186800" y="1691516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193</a:t>
              </a:r>
              <a:endParaRPr lang="en-CA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203848" y="2483604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20</a:t>
              </a:r>
              <a:endParaRPr lang="en-CA" sz="12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220072" y="2483604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173</a:t>
              </a:r>
              <a:endParaRPr lang="en-CA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444208" y="3356992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120</a:t>
              </a:r>
              <a:endParaRPr lang="en-CA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211960" y="3396790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53</a:t>
              </a:r>
              <a:endParaRPr lang="en-CA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550636" y="4365104"/>
              <a:ext cx="13732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55</a:t>
              </a:r>
            </a:p>
            <a:p>
              <a:pPr algn="ctr"/>
              <a:r>
                <a:rPr lang="en-CA" sz="1200" i="1" dirty="0" smtClean="0"/>
                <a:t>Appropriate</a:t>
              </a:r>
              <a:endParaRPr lang="en-CA" sz="1200" i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012160" y="4346520"/>
              <a:ext cx="129614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46</a:t>
              </a:r>
            </a:p>
            <a:p>
              <a:pPr algn="ctr"/>
              <a:r>
                <a:rPr lang="en-CA" sz="1200" i="1" dirty="0" smtClean="0"/>
                <a:t>Inappropriate</a:t>
              </a:r>
              <a:endParaRPr lang="en-CA" sz="1200" i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596336" y="4346520"/>
              <a:ext cx="13681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19</a:t>
              </a:r>
            </a:p>
            <a:p>
              <a:pPr algn="ctr"/>
              <a:r>
                <a:rPr lang="en-CA" sz="1200" i="1" dirty="0" smtClean="0"/>
                <a:t>Technical errors</a:t>
              </a:r>
              <a:endParaRPr lang="en-CA" sz="1200" i="1" dirty="0"/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4011372" y="404664"/>
              <a:ext cx="0" cy="278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2735796" y="692696"/>
              <a:ext cx="255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>
              <a:off x="2735796" y="692696"/>
              <a:ext cx="0" cy="28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/>
            <p:nvPr/>
          </p:nvCxnSpPr>
          <p:spPr>
            <a:xfrm>
              <a:off x="5292080" y="692696"/>
              <a:ext cx="0" cy="28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2735796" y="1196752"/>
              <a:ext cx="0" cy="278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1115616" y="1394192"/>
              <a:ext cx="3312368" cy="92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/>
            <p:nvPr/>
          </p:nvCxnSpPr>
          <p:spPr>
            <a:xfrm>
              <a:off x="1115616" y="1403484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>
              <a:off x="4427984" y="1403484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/>
            <p:cNvCxnSpPr/>
            <p:nvPr/>
          </p:nvCxnSpPr>
          <p:spPr>
            <a:xfrm>
              <a:off x="2735796" y="1403484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3347864" y="2267580"/>
              <a:ext cx="20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>
              <a:off x="3347864" y="2267580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/>
            <p:cNvCxnSpPr/>
            <p:nvPr/>
          </p:nvCxnSpPr>
          <p:spPr>
            <a:xfrm>
              <a:off x="5436096" y="2267580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4427984" y="1988840"/>
              <a:ext cx="0" cy="278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4427984" y="3159000"/>
              <a:ext cx="22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>
              <a:off x="4427984" y="3159000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>
              <a:off x="6660232" y="3159000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5436096" y="2852968"/>
              <a:ext cx="0" cy="28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6660232" y="3645024"/>
              <a:ext cx="0" cy="43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3203848" y="4065487"/>
              <a:ext cx="5040000" cy="92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>
              <a:off x="3203848" y="4074779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/>
            <p:cNvCxnSpPr/>
            <p:nvPr/>
          </p:nvCxnSpPr>
          <p:spPr>
            <a:xfrm>
              <a:off x="8244408" y="4074779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>
              <a:off x="6660232" y="4074779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3208988" y="4794859"/>
              <a:ext cx="0" cy="278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2123728" y="4992299"/>
              <a:ext cx="22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>
              <a:off x="3208988" y="4986144"/>
              <a:ext cx="0" cy="2736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2123728" y="4986144"/>
              <a:ext cx="0" cy="2736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>
              <a:off x="4361116" y="4986144"/>
              <a:ext cx="0" cy="2736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1691680" y="703729"/>
              <a:ext cx="1008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CA" sz="1200" dirty="0" smtClean="0"/>
                <a:t>(+) TTG</a:t>
              </a:r>
              <a:endParaRPr lang="en-CA" sz="12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292080" y="703729"/>
              <a:ext cx="1008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(-) TTG</a:t>
              </a:r>
              <a:endParaRPr lang="en-CA" sz="12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11560" y="1845404"/>
              <a:ext cx="1080120" cy="2828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Referred to GI</a:t>
              </a:r>
              <a:endParaRPr lang="en-CA" sz="1200" i="1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411480" y="1835532"/>
              <a:ext cx="864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Known CD</a:t>
              </a:r>
              <a:endParaRPr lang="en-CA" sz="1200" i="1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499992" y="1691516"/>
              <a:ext cx="19442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No management identified</a:t>
              </a:r>
              <a:endParaRPr lang="en-CA" sz="1200" i="1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627784" y="2636912"/>
              <a:ext cx="16561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Ordering MD unknown</a:t>
              </a:r>
              <a:endParaRPr lang="en-CA" sz="1200" i="1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5508104" y="2483604"/>
              <a:ext cx="1611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Surveys mailed out</a:t>
              </a:r>
              <a:endParaRPr lang="en-CA" sz="1200" i="1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707904" y="3543399"/>
              <a:ext cx="17819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Surveys not returned</a:t>
              </a:r>
              <a:endParaRPr lang="en-CA" sz="1200" i="1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6777080" y="3356992"/>
              <a:ext cx="1611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Completed surveys</a:t>
              </a:r>
              <a:endParaRPr lang="en-CA" sz="1200" i="1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470516" y="5229200"/>
              <a:ext cx="13732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4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2560916" y="5229200"/>
              <a:ext cx="12961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15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713044" y="5229200"/>
              <a:ext cx="13681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36</a:t>
              </a:r>
            </a:p>
          </p:txBody>
        </p:sp>
        <p:cxnSp>
          <p:nvCxnSpPr>
            <p:cNvPr id="68" name="Straight Arrow Connector 67"/>
            <p:cNvCxnSpPr/>
            <p:nvPr/>
          </p:nvCxnSpPr>
          <p:spPr>
            <a:xfrm>
              <a:off x="3203848" y="5474001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Arrow Connector 68"/>
            <p:cNvCxnSpPr/>
            <p:nvPr/>
          </p:nvCxnSpPr>
          <p:spPr>
            <a:xfrm>
              <a:off x="2123728" y="5474001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Arrow Connector 69"/>
            <p:cNvCxnSpPr/>
            <p:nvPr/>
          </p:nvCxnSpPr>
          <p:spPr>
            <a:xfrm>
              <a:off x="4355976" y="5474001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1115476" y="5744289"/>
              <a:ext cx="864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CA" sz="1200" i="1" dirty="0" smtClean="0"/>
                <a:t>EMA +</a:t>
              </a:r>
              <a:endParaRPr lang="en-CA" sz="1200" i="1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470516" y="5744289"/>
              <a:ext cx="13732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4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2560916" y="5744289"/>
              <a:ext cx="12961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5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211960" y="5744001"/>
              <a:ext cx="293172" cy="2772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/>
                <a:t>1</a:t>
              </a:r>
              <a:endParaRPr lang="en-CA" sz="1200" dirty="0" smtClean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115476" y="5013176"/>
              <a:ext cx="9362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TTG x (ULN)</a:t>
              </a:r>
              <a:endParaRPr lang="en-CA" sz="1200" i="1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123728" y="5011282"/>
              <a:ext cx="576064" cy="2788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&gt; 10 </a:t>
              </a:r>
              <a:endParaRPr lang="en-CA" sz="1200" i="1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237282" y="5011282"/>
              <a:ext cx="864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3-10</a:t>
              </a:r>
              <a:endParaRPr lang="en-CA" sz="1200" i="1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427704" y="5011282"/>
              <a:ext cx="864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1-3 </a:t>
              </a:r>
              <a:endParaRPr lang="en-CA" sz="1200" i="1" dirty="0"/>
            </a:p>
          </p:txBody>
        </p:sp>
        <p:cxnSp>
          <p:nvCxnSpPr>
            <p:cNvPr id="79" name="Straight Connector 78"/>
            <p:cNvCxnSpPr/>
            <p:nvPr/>
          </p:nvCxnSpPr>
          <p:spPr>
            <a:xfrm>
              <a:off x="6665512" y="4797152"/>
              <a:ext cx="0" cy="278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>
              <a:off x="5580112" y="4994592"/>
              <a:ext cx="22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Arrow Connector 80"/>
            <p:cNvCxnSpPr/>
            <p:nvPr/>
          </p:nvCxnSpPr>
          <p:spPr>
            <a:xfrm>
              <a:off x="6665512" y="4986144"/>
              <a:ext cx="0" cy="2736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Arrow Connector 81"/>
            <p:cNvCxnSpPr/>
            <p:nvPr/>
          </p:nvCxnSpPr>
          <p:spPr>
            <a:xfrm>
              <a:off x="5585392" y="4986144"/>
              <a:ext cx="0" cy="2736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Arrow Connector 82"/>
            <p:cNvCxnSpPr/>
            <p:nvPr/>
          </p:nvCxnSpPr>
          <p:spPr>
            <a:xfrm>
              <a:off x="7817640" y="4986144"/>
              <a:ext cx="0" cy="2736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/>
            <p:cNvSpPr txBox="1"/>
            <p:nvPr/>
          </p:nvSpPr>
          <p:spPr>
            <a:xfrm>
              <a:off x="5436096" y="5229201"/>
              <a:ext cx="288172" cy="2792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/>
                <a:t>5</a:t>
              </a:r>
              <a:endParaRPr lang="en-CA" sz="1200" dirty="0" smtClean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6017440" y="5231493"/>
              <a:ext cx="12961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10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7169568" y="5231493"/>
              <a:ext cx="13681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/>
                <a:t>31</a:t>
              </a:r>
            </a:p>
          </p:txBody>
        </p:sp>
        <p:cxnSp>
          <p:nvCxnSpPr>
            <p:cNvPr id="87" name="Straight Arrow Connector 86"/>
            <p:cNvCxnSpPr/>
            <p:nvPr/>
          </p:nvCxnSpPr>
          <p:spPr>
            <a:xfrm>
              <a:off x="6660372" y="5476294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Arrow Connector 87"/>
            <p:cNvCxnSpPr/>
            <p:nvPr/>
          </p:nvCxnSpPr>
          <p:spPr>
            <a:xfrm>
              <a:off x="5580252" y="5476294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Arrow Connector 88"/>
            <p:cNvCxnSpPr/>
            <p:nvPr/>
          </p:nvCxnSpPr>
          <p:spPr>
            <a:xfrm>
              <a:off x="7812500" y="5476294"/>
              <a:ext cx="0" cy="27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/>
            <p:cNvSpPr txBox="1"/>
            <p:nvPr/>
          </p:nvSpPr>
          <p:spPr>
            <a:xfrm>
              <a:off x="4927040" y="5744289"/>
              <a:ext cx="13732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/>
                <a:t>5</a:t>
              </a:r>
              <a:endParaRPr lang="en-CA" sz="1200" dirty="0" smtClean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6017440" y="5744289"/>
              <a:ext cx="12961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/>
                <a:t>1</a:t>
              </a:r>
              <a:endParaRPr lang="en-CA" sz="1200" dirty="0" smtClean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7668344" y="5746294"/>
              <a:ext cx="282752" cy="2749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/>
                <a:t>1</a:t>
              </a:r>
              <a:endParaRPr lang="en-CA" sz="1200" dirty="0" smtClean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5580252" y="5011282"/>
              <a:ext cx="5039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&gt; 10 </a:t>
              </a:r>
              <a:endParaRPr lang="en-CA" sz="1200" i="1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6693806" y="5011282"/>
              <a:ext cx="864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3-10</a:t>
              </a:r>
              <a:endParaRPr lang="en-CA" sz="1200" i="1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7884228" y="5011282"/>
              <a:ext cx="864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i="1" dirty="0" smtClean="0"/>
                <a:t>1-3 </a:t>
              </a:r>
              <a:endParaRPr lang="en-CA" sz="1200" i="1" dirty="0"/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251520" y="116632"/>
            <a:ext cx="900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l Figure </a:t>
            </a:r>
            <a:r>
              <a:rPr lang="en-CA" dirty="0" smtClean="0"/>
              <a:t>2: </a:t>
            </a:r>
            <a:r>
              <a:rPr lang="en-CA" dirty="0" smtClean="0"/>
              <a:t>Study flow diagram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619348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64</TotalTime>
  <Words>74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minica Dominica</dc:creator>
  <cp:lastModifiedBy>Sevilla, Hernando Jr.</cp:lastModifiedBy>
  <cp:revision>13</cp:revision>
  <dcterms:created xsi:type="dcterms:W3CDTF">2019-05-27T16:35:39Z</dcterms:created>
  <dcterms:modified xsi:type="dcterms:W3CDTF">2019-07-16T06:26:27Z</dcterms:modified>
</cp:coreProperties>
</file>